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86" autoAdjust="0"/>
  </p:normalViewPr>
  <p:slideViewPr>
    <p:cSldViewPr>
      <p:cViewPr>
        <p:scale>
          <a:sx n="130" d="100"/>
          <a:sy n="130" d="100"/>
        </p:scale>
        <p:origin x="102" y="-10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941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919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534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958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324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558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581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635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446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525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288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EB363-0A78-4AC7-95CC-1953CC43CCCD}" type="datetimeFigureOut">
              <a:rPr lang="en-US" smtClean="0"/>
              <a:t>11/18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501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uppieren 56"/>
          <p:cNvGrpSpPr>
            <a:grpSpLocks noChangeAspect="1"/>
          </p:cNvGrpSpPr>
          <p:nvPr/>
        </p:nvGrpSpPr>
        <p:grpSpPr>
          <a:xfrm>
            <a:off x="4830" y="3551110"/>
            <a:ext cx="2035548" cy="1630490"/>
            <a:chOff x="243841" y="1792416"/>
            <a:chExt cx="2261720" cy="1811655"/>
          </a:xfrm>
        </p:grpSpPr>
        <p:pic>
          <p:nvPicPr>
            <p:cNvPr id="58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942"/>
            <a:stretch/>
          </p:blipFill>
          <p:spPr bwMode="auto">
            <a:xfrm>
              <a:off x="243841" y="1792416"/>
              <a:ext cx="2261720" cy="1811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9" name="Rechteck 58"/>
            <p:cNvSpPr/>
            <p:nvPr/>
          </p:nvSpPr>
          <p:spPr>
            <a:xfrm>
              <a:off x="762000" y="2120978"/>
              <a:ext cx="164592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uppieren 2"/>
          <p:cNvGrpSpPr/>
          <p:nvPr/>
        </p:nvGrpSpPr>
        <p:grpSpPr>
          <a:xfrm>
            <a:off x="0" y="5181600"/>
            <a:ext cx="2077900" cy="1630490"/>
            <a:chOff x="4142897" y="2819400"/>
            <a:chExt cx="2077900" cy="1630490"/>
          </a:xfrm>
        </p:grpSpPr>
        <p:pic>
          <p:nvPicPr>
            <p:cNvPr id="64" name="Picture 8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0318"/>
            <a:stretch/>
          </p:blipFill>
          <p:spPr bwMode="auto">
            <a:xfrm>
              <a:off x="4142897" y="2819400"/>
              <a:ext cx="2077900" cy="16304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65" name="Gruppieren 64"/>
            <p:cNvGrpSpPr/>
            <p:nvPr/>
          </p:nvGrpSpPr>
          <p:grpSpPr>
            <a:xfrm>
              <a:off x="4609240" y="3109120"/>
              <a:ext cx="1481328" cy="82296"/>
              <a:chOff x="4164330" y="2114328"/>
              <a:chExt cx="1645920" cy="91440"/>
            </a:xfrm>
          </p:grpSpPr>
          <p:sp>
            <p:nvSpPr>
              <p:cNvPr id="66" name="Rechteck 65"/>
              <p:cNvSpPr/>
              <p:nvPr/>
            </p:nvSpPr>
            <p:spPr>
              <a:xfrm>
                <a:off x="4164330" y="2114328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  <a:endParaRPr lang="en-US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hteck 66"/>
              <p:cNvSpPr/>
              <p:nvPr/>
            </p:nvSpPr>
            <p:spPr>
              <a:xfrm>
                <a:off x="4987290" y="2114328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  <a:endParaRPr lang="en-US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8" name="Gruppieren 67"/>
          <p:cNvGrpSpPr>
            <a:grpSpLocks noChangeAspect="1"/>
          </p:cNvGrpSpPr>
          <p:nvPr/>
        </p:nvGrpSpPr>
        <p:grpSpPr>
          <a:xfrm>
            <a:off x="2529840" y="5187079"/>
            <a:ext cx="2561463" cy="1630490"/>
            <a:chOff x="3648075" y="5377248"/>
            <a:chExt cx="2846070" cy="1811655"/>
          </a:xfrm>
        </p:grpSpPr>
        <p:pic>
          <p:nvPicPr>
            <p:cNvPr id="69" name="Picture 10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8075" y="5377248"/>
              <a:ext cx="2846070" cy="1811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70" name="Gruppieren 69"/>
            <p:cNvGrpSpPr/>
            <p:nvPr/>
          </p:nvGrpSpPr>
          <p:grpSpPr>
            <a:xfrm>
              <a:off x="4119134" y="5698902"/>
              <a:ext cx="1645920" cy="91440"/>
              <a:chOff x="4168664" y="5698902"/>
              <a:chExt cx="1645920" cy="91440"/>
            </a:xfrm>
          </p:grpSpPr>
          <p:sp>
            <p:nvSpPr>
              <p:cNvPr id="71" name="Rechteck 70"/>
              <p:cNvSpPr/>
              <p:nvPr/>
            </p:nvSpPr>
            <p:spPr>
              <a:xfrm>
                <a:off x="4168664" y="5698902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  <a:endParaRPr lang="en-US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hteck 71"/>
              <p:cNvSpPr/>
              <p:nvPr/>
            </p:nvSpPr>
            <p:spPr>
              <a:xfrm>
                <a:off x="4991624" y="5698902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  <a:endParaRPr lang="en-US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9" name="Gruppieren 28"/>
          <p:cNvGrpSpPr>
            <a:grpSpLocks noChangeAspect="1"/>
          </p:cNvGrpSpPr>
          <p:nvPr/>
        </p:nvGrpSpPr>
        <p:grpSpPr>
          <a:xfrm>
            <a:off x="76200" y="76962"/>
            <a:ext cx="1998502" cy="1630490"/>
            <a:chOff x="289561" y="1792416"/>
            <a:chExt cx="2220558" cy="1811655"/>
          </a:xfrm>
        </p:grpSpPr>
        <p:pic>
          <p:nvPicPr>
            <p:cNvPr id="30" name="Picture 3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9738"/>
            <a:stretch/>
          </p:blipFill>
          <p:spPr bwMode="auto">
            <a:xfrm>
              <a:off x="289561" y="1792416"/>
              <a:ext cx="2220558" cy="1811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4" name="Rechteck 33"/>
            <p:cNvSpPr/>
            <p:nvPr/>
          </p:nvSpPr>
          <p:spPr>
            <a:xfrm>
              <a:off x="798721" y="2120978"/>
              <a:ext cx="164592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uppieren 34"/>
          <p:cNvGrpSpPr>
            <a:grpSpLocks noChangeAspect="1"/>
          </p:cNvGrpSpPr>
          <p:nvPr/>
        </p:nvGrpSpPr>
        <p:grpSpPr>
          <a:xfrm>
            <a:off x="57825" y="1752600"/>
            <a:ext cx="2025127" cy="1630490"/>
            <a:chOff x="3657600" y="1792416"/>
            <a:chExt cx="2250141" cy="1811655"/>
          </a:xfrm>
        </p:grpSpPr>
        <p:pic>
          <p:nvPicPr>
            <p:cNvPr id="41" name="Picture 8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8802"/>
            <a:stretch/>
          </p:blipFill>
          <p:spPr bwMode="auto">
            <a:xfrm>
              <a:off x="3657600" y="1792416"/>
              <a:ext cx="2250141" cy="1811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42" name="Gruppieren 41"/>
            <p:cNvGrpSpPr/>
            <p:nvPr/>
          </p:nvGrpSpPr>
          <p:grpSpPr>
            <a:xfrm>
              <a:off x="4164330" y="2114328"/>
              <a:ext cx="1645920" cy="91440"/>
              <a:chOff x="4164330" y="2114328"/>
              <a:chExt cx="1645920" cy="91440"/>
            </a:xfrm>
          </p:grpSpPr>
          <p:sp>
            <p:nvSpPr>
              <p:cNvPr id="47" name="Rechteck 46"/>
              <p:cNvSpPr/>
              <p:nvPr/>
            </p:nvSpPr>
            <p:spPr>
              <a:xfrm>
                <a:off x="4164330" y="2114328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  <a:endParaRPr lang="en-US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hteck 47"/>
              <p:cNvSpPr/>
              <p:nvPr/>
            </p:nvSpPr>
            <p:spPr>
              <a:xfrm>
                <a:off x="4987290" y="2114328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  <a:endParaRPr lang="en-US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52" name="Gruppieren 51"/>
          <p:cNvGrpSpPr>
            <a:grpSpLocks noChangeAspect="1"/>
          </p:cNvGrpSpPr>
          <p:nvPr/>
        </p:nvGrpSpPr>
        <p:grpSpPr>
          <a:xfrm>
            <a:off x="2468186" y="1752600"/>
            <a:ext cx="2885504" cy="1630490"/>
            <a:chOff x="3611880" y="5377248"/>
            <a:chExt cx="3206115" cy="1811655"/>
          </a:xfrm>
        </p:grpSpPr>
        <p:pic>
          <p:nvPicPr>
            <p:cNvPr id="53" name="Picture 1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11880" y="5377248"/>
              <a:ext cx="3206115" cy="1811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54" name="Gruppieren 53"/>
            <p:cNvGrpSpPr/>
            <p:nvPr/>
          </p:nvGrpSpPr>
          <p:grpSpPr>
            <a:xfrm>
              <a:off x="4168664" y="5698902"/>
              <a:ext cx="1645920" cy="91440"/>
              <a:chOff x="4168664" y="5698902"/>
              <a:chExt cx="1645920" cy="91440"/>
            </a:xfrm>
          </p:grpSpPr>
          <p:sp>
            <p:nvSpPr>
              <p:cNvPr id="55" name="Rechteck 54"/>
              <p:cNvSpPr/>
              <p:nvPr/>
            </p:nvSpPr>
            <p:spPr>
              <a:xfrm>
                <a:off x="4168664" y="5698902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  <a:endParaRPr lang="en-US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hteck 55"/>
              <p:cNvSpPr/>
              <p:nvPr/>
            </p:nvSpPr>
            <p:spPr>
              <a:xfrm>
                <a:off x="4991624" y="5698902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  <a:endParaRPr lang="en-US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2" name="Textfeld 21"/>
          <p:cNvSpPr txBox="1"/>
          <p:nvPr/>
        </p:nvSpPr>
        <p:spPr>
          <a:xfrm>
            <a:off x="5349903" y="3858504"/>
            <a:ext cx="3794097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ange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itostero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/c/e/g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desmostero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b/d/f/h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the brain structures cortex, hippocampus, hypothalamus, and cerebellum (top), liver and plasma (bottom) from male C57BL6/J mice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imal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re at an age of 8 weeks when starting the different diet feeding and first analyzed at 12 weeks in age (4 weeks on diet). Mice were fed either a standard chow diet (SC) from age 8 to 44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eks (a/b/e/f)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 a diet switc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/d/g/h) starting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ith a coconut oil-based high-fat diet (HF) from age 8 to 32 weeks, followed by a SC from 32 to 44 weeks of ag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fferent colors of the bar segments indicate the concentration of eac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truc-tur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atrix separately. All concentrations were summed up to the total concentration which is expressed by the bar heigh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9622" y="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362200" y="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29622" y="167640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29622" y="344360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2362200" y="3443603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29622" y="505651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2362200" y="167640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2362200" y="505651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Gerader Verbinder 42"/>
          <p:cNvCxnSpPr/>
          <p:nvPr/>
        </p:nvCxnSpPr>
        <p:spPr>
          <a:xfrm>
            <a:off x="0" y="3429000"/>
            <a:ext cx="5181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" name="Gruppieren 3"/>
          <p:cNvGrpSpPr/>
          <p:nvPr/>
        </p:nvGrpSpPr>
        <p:grpSpPr>
          <a:xfrm>
            <a:off x="2463637" y="76200"/>
            <a:ext cx="2925738" cy="1630490"/>
            <a:chOff x="2463637" y="76200"/>
            <a:chExt cx="2925738" cy="1630490"/>
          </a:xfrm>
        </p:grpSpPr>
        <p:grpSp>
          <p:nvGrpSpPr>
            <p:cNvPr id="49" name="Gruppieren 48"/>
            <p:cNvGrpSpPr>
              <a:grpSpLocks noChangeAspect="1"/>
            </p:cNvGrpSpPr>
            <p:nvPr/>
          </p:nvGrpSpPr>
          <p:grpSpPr>
            <a:xfrm>
              <a:off x="2463637" y="76200"/>
              <a:ext cx="2039651" cy="1630490"/>
              <a:chOff x="243840" y="5377248"/>
              <a:chExt cx="2266279" cy="1811655"/>
            </a:xfrm>
          </p:grpSpPr>
          <p:pic>
            <p:nvPicPr>
              <p:cNvPr id="50" name="Picture 5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9314"/>
              <a:stretch/>
            </p:blipFill>
            <p:spPr bwMode="auto">
              <a:xfrm>
                <a:off x="243840" y="5377248"/>
                <a:ext cx="2266279" cy="18116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1" name="Rechteck 50"/>
              <p:cNvSpPr/>
              <p:nvPr/>
            </p:nvSpPr>
            <p:spPr>
              <a:xfrm>
                <a:off x="798721" y="5698045"/>
                <a:ext cx="164592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  <a:endParaRPr lang="en-US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61" name="Picture 10"/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851"/>
            <a:stretch/>
          </p:blipFill>
          <p:spPr bwMode="auto">
            <a:xfrm>
              <a:off x="4548272" y="76200"/>
              <a:ext cx="841103" cy="16304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5" name="Gruppieren 4"/>
          <p:cNvGrpSpPr/>
          <p:nvPr/>
        </p:nvGrpSpPr>
        <p:grpSpPr>
          <a:xfrm>
            <a:off x="2529840" y="3505200"/>
            <a:ext cx="2575560" cy="1676400"/>
            <a:chOff x="2529840" y="3505200"/>
            <a:chExt cx="2575560" cy="1676400"/>
          </a:xfrm>
        </p:grpSpPr>
        <p:grpSp>
          <p:nvGrpSpPr>
            <p:cNvPr id="2" name="Gruppieren 1"/>
            <p:cNvGrpSpPr/>
            <p:nvPr/>
          </p:nvGrpSpPr>
          <p:grpSpPr>
            <a:xfrm>
              <a:off x="2529840" y="3536977"/>
              <a:ext cx="2194560" cy="1644623"/>
              <a:chOff x="2088974" y="2819400"/>
              <a:chExt cx="2194560" cy="1644623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88974" y="2819400"/>
                <a:ext cx="2194560" cy="16446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2" name="Rechteck 61"/>
              <p:cNvSpPr/>
              <p:nvPr/>
            </p:nvSpPr>
            <p:spPr>
              <a:xfrm>
                <a:off x="2509027" y="3108114"/>
                <a:ext cx="1481328" cy="8229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  <a:endParaRPr lang="en-US" sz="6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76" name="Picture 10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751"/>
            <a:stretch/>
          </p:blipFill>
          <p:spPr bwMode="auto">
            <a:xfrm>
              <a:off x="4509897" y="3505200"/>
              <a:ext cx="595503" cy="16304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82094488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5</Words>
  <Application>Microsoft Office PowerPoint</Application>
  <PresentationFormat>Bildschirmpräsentation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22</cp:revision>
  <cp:lastPrinted>2020-04-21T16:21:37Z</cp:lastPrinted>
  <dcterms:created xsi:type="dcterms:W3CDTF">2020-04-20T12:29:51Z</dcterms:created>
  <dcterms:modified xsi:type="dcterms:W3CDTF">2021-11-18T18:19:05Z</dcterms:modified>
</cp:coreProperties>
</file>